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86"/>
    <p:restoredTop sz="94609"/>
  </p:normalViewPr>
  <p:slideViewPr>
    <p:cSldViewPr snapToGrid="0">
      <p:cViewPr varScale="1">
        <p:scale>
          <a:sx n="113" d="100"/>
          <a:sy n="113" d="100"/>
        </p:scale>
        <p:origin x="32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2CE567-1B9D-1FB0-E06A-0E871DA662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C68DE6A-D3B0-1161-377D-7A6F4E3FEB0F}"/>
              </a:ext>
            </a:extLst>
          </p:cNvPr>
          <p:cNvSpPr txBox="1"/>
          <p:nvPr/>
        </p:nvSpPr>
        <p:spPr>
          <a:xfrm>
            <a:off x="267226" y="505307"/>
            <a:ext cx="2680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D89936-EB6E-9792-CA88-06335161CFEE}"/>
              </a:ext>
            </a:extLst>
          </p:cNvPr>
          <p:cNvSpPr txBox="1"/>
          <p:nvPr/>
        </p:nvSpPr>
        <p:spPr>
          <a:xfrm>
            <a:off x="3487048" y="505306"/>
            <a:ext cx="272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00C2EF-AE00-9D76-EC80-4B3CF3FB048E}"/>
              </a:ext>
            </a:extLst>
          </p:cNvPr>
          <p:cNvSpPr txBox="1"/>
          <p:nvPr/>
        </p:nvSpPr>
        <p:spPr>
          <a:xfrm>
            <a:off x="202777" y="8070613"/>
            <a:ext cx="6194322" cy="80021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  <a:latin typeface="Helvetica Neue"/>
              </a:rPr>
              <a:t>Supplementary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Figure S5. Real-world outcomes of patients with TF below LOQ at both timepoints, ≥80% decrease at T1, T2 or T3 compared to prior timepoint, or &lt;80% decrease or increase in TF across timepoints (n=521).  (A) K-M curve for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PF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(B) K-M curve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O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(C) Median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PF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and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O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for each group (D) HR for comparison between MR and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nMR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groups(E) CPH forest plot for ≥80% decrease for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PF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(F) CPH forest plot for ≥80% decrease for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O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(G) CPH forest plot for below LOQ for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PF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 (H) CPH forest plot for below LOQ for </a:t>
            </a:r>
            <a:r>
              <a:rPr lang="en-US" sz="900" b="0" i="0" dirty="0" err="1">
                <a:solidFill>
                  <a:srgbClr val="000000"/>
                </a:solidFill>
                <a:effectLst/>
                <a:latin typeface="Helvetica Neue"/>
              </a:rPr>
              <a:t>rwOS</a:t>
            </a:r>
            <a:r>
              <a:rPr lang="en-US" sz="900" b="0" i="0" dirty="0">
                <a:solidFill>
                  <a:srgbClr val="000000"/>
                </a:solidFill>
                <a:effectLst/>
                <a:latin typeface="Helvetica Neue"/>
              </a:rPr>
              <a:t>. 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Helvetica Neue"/>
              </a:rPr>
              <a:t>   </a:t>
            </a:r>
            <a:endParaRPr lang="en-US" sz="1000" dirty="0">
              <a:latin typeface="Helvetica Neue"/>
            </a:endParaRPr>
          </a:p>
        </p:txBody>
      </p:sp>
      <p:pic>
        <p:nvPicPr>
          <p:cNvPr id="4" name="Picture 3" descr="A graph of a number of patients with a number of months&#10;&#10;Description automatically generated with medium confidence">
            <a:extLst>
              <a:ext uri="{FF2B5EF4-FFF2-40B4-BE49-F238E27FC236}">
                <a16:creationId xmlns:a16="http://schemas.microsoft.com/office/drawing/2014/main" id="{FA01D24C-11B7-DC16-9A1A-C251D16DD7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777" y="751527"/>
            <a:ext cx="2964636" cy="291889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53D402A-3D6E-4826-DBDE-7DBF2DA93E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2657" y="751527"/>
            <a:ext cx="2964637" cy="2918899"/>
          </a:xfrm>
          <a:prstGeom prst="rect">
            <a:avLst/>
          </a:prstGeom>
        </p:spPr>
      </p:pic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8C25A39A-4417-4A9A-7D4A-33E8286EDD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0743133"/>
              </p:ext>
            </p:extLst>
          </p:nvPr>
        </p:nvGraphicFramePr>
        <p:xfrm>
          <a:off x="717283" y="3796543"/>
          <a:ext cx="2302880" cy="1188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3987">
                  <a:extLst>
                    <a:ext uri="{9D8B030D-6E8A-4147-A177-3AD203B41FA5}">
                      <a16:colId xmlns:a16="http://schemas.microsoft.com/office/drawing/2014/main" val="3734862055"/>
                    </a:ext>
                  </a:extLst>
                </a:gridCol>
                <a:gridCol w="758103">
                  <a:extLst>
                    <a:ext uri="{9D8B030D-6E8A-4147-A177-3AD203B41FA5}">
                      <a16:colId xmlns:a16="http://schemas.microsoft.com/office/drawing/2014/main" val="2533721897"/>
                    </a:ext>
                  </a:extLst>
                </a:gridCol>
                <a:gridCol w="850790">
                  <a:extLst>
                    <a:ext uri="{9D8B030D-6E8A-4147-A177-3AD203B41FA5}">
                      <a16:colId xmlns:a16="http://schemas.microsoft.com/office/drawing/2014/main" val="26412837"/>
                    </a:ext>
                  </a:extLst>
                </a:gridCol>
              </a:tblGrid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F Change Group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edian rwPFS 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edian rwOS </a:t>
                      </a:r>
                    </a:p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3133311"/>
                  </a:ext>
                </a:extLst>
              </a:tr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Below LOQ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[NR-NR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[NR-NR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79013921"/>
                  </a:ext>
                </a:extLst>
              </a:tr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≥80% Decrea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[11.60-NR]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[NR-NR]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96598935"/>
                  </a:ext>
                </a:extLst>
              </a:tr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80% Decrea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10 [3.53-4.63]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57 [4.60-11.27]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62107925"/>
                  </a:ext>
                </a:extLst>
              </a:tr>
              <a:tr h="155625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ncreas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90 [2.93-4.33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07 [5.10-9.00]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0601421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CF3787C6-59C5-F3A0-83FD-BEE2C3AF3823}"/>
              </a:ext>
            </a:extLst>
          </p:cNvPr>
          <p:cNvSpPr txBox="1"/>
          <p:nvPr/>
        </p:nvSpPr>
        <p:spPr>
          <a:xfrm>
            <a:off x="260152" y="352760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94D50B2-E2A2-BA70-47E2-966D7E35BC52}"/>
              </a:ext>
            </a:extLst>
          </p:cNvPr>
          <p:cNvSpPr txBox="1"/>
          <p:nvPr/>
        </p:nvSpPr>
        <p:spPr>
          <a:xfrm>
            <a:off x="3482240" y="3527608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D</a:t>
            </a:r>
          </a:p>
        </p:txBody>
      </p:sp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id="{F8296135-802F-D551-E156-5DA01D65CD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5371264"/>
              </p:ext>
            </p:extLst>
          </p:nvPr>
        </p:nvGraphicFramePr>
        <p:xfrm>
          <a:off x="3756674" y="3921179"/>
          <a:ext cx="2302880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3987">
                  <a:extLst>
                    <a:ext uri="{9D8B030D-6E8A-4147-A177-3AD203B41FA5}">
                      <a16:colId xmlns:a16="http://schemas.microsoft.com/office/drawing/2014/main" val="3734862055"/>
                    </a:ext>
                  </a:extLst>
                </a:gridCol>
                <a:gridCol w="758103">
                  <a:extLst>
                    <a:ext uri="{9D8B030D-6E8A-4147-A177-3AD203B41FA5}">
                      <a16:colId xmlns:a16="http://schemas.microsoft.com/office/drawing/2014/main" val="2533721897"/>
                    </a:ext>
                  </a:extLst>
                </a:gridCol>
                <a:gridCol w="850790">
                  <a:extLst>
                    <a:ext uri="{9D8B030D-6E8A-4147-A177-3AD203B41FA5}">
                      <a16:colId xmlns:a16="http://schemas.microsoft.com/office/drawing/2014/main" val="26412837"/>
                    </a:ext>
                  </a:extLst>
                </a:gridCol>
              </a:tblGrid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omparis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Log-rank rwPFS HR [95% CI]; p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Log-rank rwOS </a:t>
                      </a:r>
                    </a:p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R [95% CI]; p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3133311"/>
                  </a:ext>
                </a:extLst>
              </a:tr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Below LOQ vs. nMR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17 [0.10-0.29]; &lt; 0.0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11 [0.05-0.24]; </a:t>
                      </a:r>
                    </a:p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79013921"/>
                  </a:ext>
                </a:extLst>
              </a:tr>
              <a:tr h="156293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≥80% Decrease vs. nMR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8 [0.21-0.36]; &lt; 0.0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1 [0.23-0.42];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598935"/>
                  </a:ext>
                </a:extLst>
              </a:tr>
            </a:tbl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C467A024-4C2D-78F7-EE34-CF0F3E77F994}"/>
              </a:ext>
            </a:extLst>
          </p:cNvPr>
          <p:cNvSpPr txBox="1"/>
          <p:nvPr/>
        </p:nvSpPr>
        <p:spPr>
          <a:xfrm>
            <a:off x="262159" y="494865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1B22B31-55EB-804D-A6AF-6A207ED8D596}"/>
              </a:ext>
            </a:extLst>
          </p:cNvPr>
          <p:cNvSpPr txBox="1"/>
          <p:nvPr/>
        </p:nvSpPr>
        <p:spPr>
          <a:xfrm>
            <a:off x="3498270" y="4948654"/>
            <a:ext cx="2584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F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8FBE68C-C633-D5C9-2629-CF9DA4271EF1}"/>
              </a:ext>
            </a:extLst>
          </p:cNvPr>
          <p:cNvSpPr txBox="1"/>
          <p:nvPr/>
        </p:nvSpPr>
        <p:spPr>
          <a:xfrm>
            <a:off x="260012" y="6532558"/>
            <a:ext cx="282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96FB791-46D9-BB73-EBFF-739B99B34B2B}"/>
              </a:ext>
            </a:extLst>
          </p:cNvPr>
          <p:cNvSpPr txBox="1"/>
          <p:nvPr/>
        </p:nvSpPr>
        <p:spPr>
          <a:xfrm>
            <a:off x="3492575" y="653255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H</a:t>
            </a:r>
          </a:p>
        </p:txBody>
      </p:sp>
      <p:pic>
        <p:nvPicPr>
          <p:cNvPr id="3" name="Picture 2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A74A5CE0-1489-94A0-2C7C-C0543782EB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226" y="5214135"/>
            <a:ext cx="3083311" cy="1236726"/>
          </a:xfrm>
          <a:prstGeom prst="rect">
            <a:avLst/>
          </a:prstGeom>
        </p:spPr>
      </p:pic>
      <p:pic>
        <p:nvPicPr>
          <p:cNvPr id="8" name="Picture 7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80552CD9-1F41-BB02-8464-4CFA0A79E8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7466" y="5214135"/>
            <a:ext cx="3083308" cy="1236725"/>
          </a:xfrm>
          <a:prstGeom prst="rect">
            <a:avLst/>
          </a:prstGeom>
        </p:spPr>
      </p:pic>
      <p:pic>
        <p:nvPicPr>
          <p:cNvPr id="14" name="Picture 13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629AAA4B-4857-AB33-EECA-CF05961C52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7226" y="6810953"/>
            <a:ext cx="3083308" cy="1236725"/>
          </a:xfrm>
          <a:prstGeom prst="rect">
            <a:avLst/>
          </a:prstGeom>
        </p:spPr>
      </p:pic>
      <p:pic>
        <p:nvPicPr>
          <p:cNvPr id="18" name="Picture 17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0895B0BD-6F98-124B-A214-110B0FA46D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07466" y="6814301"/>
            <a:ext cx="3083308" cy="12367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92B6CD9-C56A-746E-E21C-81246E6D83EC}"/>
              </a:ext>
            </a:extLst>
          </p:cNvPr>
          <p:cNvSpPr txBox="1"/>
          <p:nvPr/>
        </p:nvSpPr>
        <p:spPr>
          <a:xfrm>
            <a:off x="92969" y="95126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latin typeface="Helvetica Neue"/>
              </a:rPr>
              <a:t>Supplementary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Helvetica Neue"/>
              </a:rPr>
              <a:t> Figure S5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8920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9</TotalTime>
  <Words>257</Words>
  <Application>Microsoft Macintosh PowerPoint</Application>
  <PresentationFormat>Letter Paper (8.5x11 in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5</cp:revision>
  <dcterms:created xsi:type="dcterms:W3CDTF">2024-12-13T18:22:33Z</dcterms:created>
  <dcterms:modified xsi:type="dcterms:W3CDTF">2025-07-09T17:16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